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16D8D8-6D62-4378-B3B2-F23515D00D7D}" v="3" dt="2020-07-20T14:47:14.9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 snapToObjects="1">
      <p:cViewPr varScale="1">
        <p:scale>
          <a:sx n="104" d="100"/>
          <a:sy n="104" d="100"/>
        </p:scale>
        <p:origin x="89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úl Castanera Andrés" userId="S::raul.castanera@unavarra.es::21465e0c-191f-4c0b-8344-8cd86ef4ab86" providerId="AD" clId="Web-{7516D8D8-6D62-4378-B3B2-F23515D00D7D}"/>
    <pc:docChg chg="modSld">
      <pc:chgData name="Raúl Castanera Andrés" userId="S::raul.castanera@unavarra.es::21465e0c-191f-4c0b-8344-8cd86ef4ab86" providerId="AD" clId="Web-{7516D8D8-6D62-4378-B3B2-F23515D00D7D}" dt="2020-07-20T14:47:14.930" v="2" actId="1076"/>
      <pc:docMkLst>
        <pc:docMk/>
      </pc:docMkLst>
      <pc:sldChg chg="addSp modSp">
        <pc:chgData name="Raúl Castanera Andrés" userId="S::raul.castanera@unavarra.es::21465e0c-191f-4c0b-8344-8cd86ef4ab86" providerId="AD" clId="Web-{7516D8D8-6D62-4378-B3B2-F23515D00D7D}" dt="2020-07-20T14:47:14.930" v="2" actId="1076"/>
        <pc:sldMkLst>
          <pc:docMk/>
          <pc:sldMk cId="1226388702" sldId="256"/>
        </pc:sldMkLst>
        <pc:picChg chg="add mod">
          <ac:chgData name="Raúl Castanera Andrés" userId="S::raul.castanera@unavarra.es::21465e0c-191f-4c0b-8344-8cd86ef4ab86" providerId="AD" clId="Web-{7516D8D8-6D62-4378-B3B2-F23515D00D7D}" dt="2020-07-20T14:47:14.930" v="2" actId="1076"/>
          <ac:picMkLst>
            <pc:docMk/>
            <pc:sldMk cId="1226388702" sldId="256"/>
            <ac:picMk id="2" creationId="{157ABFB6-7C6A-4A3E-98A7-C9CF0ED2D03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A75D5C-6CD2-0240-B906-474BE7501E63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32121F-59A5-C341-B1D0-67EC422FECFC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805843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32121F-59A5-C341-B1D0-67EC422FECFC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6983300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EF41D-7BDD-F146-B700-8066C1E5F6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E7598C-E628-A147-97D5-74169ED9B5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15A77E-4AB5-394A-BD7A-B37C36D75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7C3B05-C07D-7249-9B20-AEFB24B12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89900-21EA-5849-A55C-F302A2CA6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16828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B266D0-5D6C-0D44-8252-CE60D1548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BE1F78-1F7D-A948-9FCD-1FF1137477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27695D-992A-1A4F-AD6F-3181F7B32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FFC8B2-88F2-FA43-A714-E31597CAD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019739-05C4-194C-819C-66A856897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52693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705CD6-BFEC-BD43-9C3D-B224123832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20867F-6391-EE45-82C9-5FAAE54AD0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6F7938-6656-6B45-B58D-90E2987F0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D8456D-1CEF-B143-B869-89974519F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1A8EC7-CAA1-CF40-B7CB-2A04E5E1F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967881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AB1BE-B323-ED43-9150-A63210718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F71675-E7C6-204A-B620-EAA3A5C41F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75ED89-84DF-4545-BB6F-ED9FD9FB1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033D21-3885-F542-890F-4D640F757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E6F1A6-AAC4-6842-8A6D-2D436D8FC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73377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7FF63B-3FEE-D542-A8E7-BBB541A9C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7ADD7B-830D-F741-9868-04D06A8666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9D2A7-3F04-9740-B005-D5489F058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41146-0838-B84D-93A0-DBCD20A47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51A13-D737-C649-806A-218A7C4D6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28952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38888-24AA-514D-91EB-7A44294464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75917-8D41-CB40-85CB-8014295A09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A6666-B0C5-FE44-B579-94834EAA9A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9C3BD9-B276-2E4A-8991-DB455F8D9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61B761-BC80-4848-AD53-800148020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AB09B9-8EB6-0A40-AB51-6DE5DF121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4424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85C16-A695-AA49-AEE9-31FCA615D4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00E926-8305-944D-ADA1-D5F366604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C07820-9996-8745-B7F3-1A0D25EBB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3ECB6B6-F13E-4B4B-82B2-9B7BA6F51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68CD92-5986-2947-9040-522741580E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B5A999-2A3D-F944-8F92-868BA84A0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9E01DF-E53A-DC48-9FD9-0AA0C8B29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E6F44D-FCF5-564A-A704-5A951649D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73121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397EC-7F0F-4B4D-B1B3-D409CBD4B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365055-65FC-404F-8B22-023126CBF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79143A-0B93-624E-A5FF-66809E004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397D45-79C3-EC41-9A03-9337F02D8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113093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5655C8-56E2-F046-ABDE-92FC02D58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6D8F4E-4AA9-3448-ACA5-A8F043425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24EB57-9D91-264B-A161-9693BA422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699045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C4107-7C7E-9046-912B-64085CE477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D3B063-ADBE-874B-85EC-A36B5CF3AE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B1DE76-D2AB-5941-B20A-8CE368B909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1E9CD4-595A-E54B-8178-D9479653C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AFA8E4-AAA7-F34F-9A1D-CBCC021EF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7067D8-AACD-A04C-B541-501C10EE2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395308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9AAA7-A57D-394F-931A-1AE00F402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097736-9443-E248-A997-53660FE339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C47D05-EEB9-BA46-A3ED-56C08E604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FE32E-DDFC-A343-A37C-B49725049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068AD4-F40F-3B40-A142-AD9A8FDA6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D744E2-4C93-504F-B7DB-0BCFB39CD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28710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0A8A4F-A6BF-8C4B-A3B1-A4275FB5C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7B2235-5D67-A94D-8CB7-2083F0FC8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F5972E-17AC-994B-BBE0-52D9F73ED3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6B314-F424-B44A-BBAA-12D459FE721A}" type="datetimeFigureOut">
              <a:rPr lang="en-ES" smtClean="0"/>
              <a:t>06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755AF-CB02-2C45-B7A2-1ABE75F29D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80228-4CEB-0541-AD10-299FEDADE0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2841F3-5826-604A-A5D1-AA9491D98729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78232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385B9CF-2A7F-354B-8F41-41A035FF80E8}"/>
              </a:ext>
            </a:extLst>
          </p:cNvPr>
          <p:cNvGrpSpPr>
            <a:grpSpLocks noChangeAspect="1"/>
          </p:cNvGrpSpPr>
          <p:nvPr/>
        </p:nvGrpSpPr>
        <p:grpSpPr>
          <a:xfrm>
            <a:off x="793147" y="71432"/>
            <a:ext cx="10276143" cy="6040046"/>
            <a:chOff x="621694" y="71431"/>
            <a:chExt cx="11546227" cy="6786569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AF9A88C-3C84-8041-A881-CF12E9E0FA1F}"/>
                </a:ext>
              </a:extLst>
            </p:cNvPr>
            <p:cNvGrpSpPr/>
            <p:nvPr/>
          </p:nvGrpSpPr>
          <p:grpSpPr>
            <a:xfrm>
              <a:off x="621694" y="71431"/>
              <a:ext cx="10613909" cy="6786569"/>
              <a:chOff x="621694" y="71431"/>
              <a:chExt cx="10613909" cy="678656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43D475C2-B9C4-9E45-9F14-DCB6553164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21694" y="785806"/>
                <a:ext cx="2588079" cy="2257425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08F8E43-F083-A14A-BA59-F32F69281AE0}"/>
                  </a:ext>
                </a:extLst>
              </p:cNvPr>
              <p:cNvSpPr txBox="1"/>
              <p:nvPr/>
            </p:nvSpPr>
            <p:spPr>
              <a:xfrm>
                <a:off x="1713604" y="71431"/>
                <a:ext cx="5918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DHX</a:t>
                </a: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53B8349C-23EF-9845-A623-46A333AD12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272651" y="699009"/>
                <a:ext cx="2828235" cy="2462740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A04BC89-B236-9649-8048-07DCE70E078F}"/>
                  </a:ext>
                </a:extLst>
              </p:cNvPr>
              <p:cNvSpPr txBox="1"/>
              <p:nvPr/>
            </p:nvSpPr>
            <p:spPr>
              <a:xfrm>
                <a:off x="5408167" y="71431"/>
                <a:ext cx="5572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DTX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7273E95-0042-6342-BD87-EA3B0F6AC9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695616" y="256097"/>
                <a:ext cx="3044337" cy="3429001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B2179B8-9789-214B-A407-435C7076ABF0}"/>
                  </a:ext>
                </a:extLst>
              </p:cNvPr>
              <p:cNvSpPr txBox="1"/>
              <p:nvPr/>
            </p:nvSpPr>
            <p:spPr>
              <a:xfrm>
                <a:off x="9561066" y="71431"/>
                <a:ext cx="6639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MITE</a:t>
                </a:r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AEA1594F-5744-F84E-BC78-08EC40C97D8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80150" y="4029076"/>
                <a:ext cx="2652678" cy="2671762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775E5B6-322B-4F41-8B90-3B0290B08791}"/>
                  </a:ext>
                </a:extLst>
              </p:cNvPr>
              <p:cNvSpPr txBox="1"/>
              <p:nvPr/>
            </p:nvSpPr>
            <p:spPr>
              <a:xfrm>
                <a:off x="1897384" y="3486146"/>
                <a:ext cx="4876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RIX</a:t>
                </a:r>
              </a:p>
            </p:txBody>
          </p:sp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13D2E2FF-D383-9B4F-BF00-529313ED51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272651" y="3916782"/>
                <a:ext cx="3212079" cy="2797306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4594782-88BB-C84B-84F5-9709F3A134F8}"/>
                  </a:ext>
                </a:extLst>
              </p:cNvPr>
              <p:cNvSpPr txBox="1"/>
              <p:nvPr/>
            </p:nvSpPr>
            <p:spPr>
              <a:xfrm>
                <a:off x="5800085" y="3512566"/>
                <a:ext cx="52770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RLX</a:t>
                </a:r>
              </a:p>
            </p:txBody>
          </p:sp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E0697DDB-A107-CC47-9FE3-DF6F081CA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97920" y="4147594"/>
                <a:ext cx="3037683" cy="2710406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620C763-0137-624C-82F7-D91F0134995E}"/>
                  </a:ext>
                </a:extLst>
              </p:cNvPr>
              <p:cNvSpPr txBox="1"/>
              <p:nvPr/>
            </p:nvSpPr>
            <p:spPr>
              <a:xfrm>
                <a:off x="9770305" y="3547014"/>
                <a:ext cx="531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ES" dirty="0"/>
                  <a:t>RSX</a:t>
                </a:r>
              </a:p>
            </p:txBody>
          </p:sp>
        </p:grpSp>
        <p:pic>
          <p:nvPicPr>
            <p:cNvPr id="2" name="Imagen 2">
              <a:extLst>
                <a:ext uri="{FF2B5EF4-FFF2-40B4-BE49-F238E27FC236}">
                  <a16:creationId xmlns:a16="http://schemas.microsoft.com/office/drawing/2014/main" id="{157ABFB6-7C6A-4A3E-98A7-C9CF0ED2D03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764650" y="146957"/>
              <a:ext cx="1403271" cy="4114800"/>
            </a:xfrm>
            <a:prstGeom prst="rect">
              <a:avLst/>
            </a:prstGeom>
          </p:spPr>
        </p:pic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E73E5197-A76D-D846-80C5-6AF8C194FD70}"/>
              </a:ext>
            </a:extLst>
          </p:cNvPr>
          <p:cNvSpPr/>
          <p:nvPr/>
        </p:nvSpPr>
        <p:spPr>
          <a:xfrm>
            <a:off x="302795" y="6168630"/>
            <a:ext cx="1158641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3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Neighbor-joining trees based on TIPs from six different TE groups. </a:t>
            </a:r>
            <a:r>
              <a:rPr lang="en-ES" dirty="0"/>
              <a:t>DHX = Helitron</a:t>
            </a:r>
            <a:r>
              <a:rPr lang="en-ES"/>
              <a:t>, DTX </a:t>
            </a:r>
            <a:r>
              <a:rPr lang="en-ES" dirty="0"/>
              <a:t>= TIR transposons, RIX = LINEs, RLX = LTR-retrotransposons, RSX = SINEs. 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6388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3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úl Castanera Andrés</dc:creator>
  <cp:lastModifiedBy>Raúl Castanera Andrés</cp:lastModifiedBy>
  <cp:revision>6</cp:revision>
  <dcterms:created xsi:type="dcterms:W3CDTF">2020-07-13T15:20:14Z</dcterms:created>
  <dcterms:modified xsi:type="dcterms:W3CDTF">2020-11-06T11:22:01Z</dcterms:modified>
</cp:coreProperties>
</file>